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85" r:id="rId2"/>
    <p:sldId id="38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62" userDrawn="1">
          <p15:clr>
            <a:srgbClr val="A4A3A4"/>
          </p15:clr>
        </p15:guide>
        <p15:guide id="2" pos="166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hard Magee" initials="RM" lastIdx="19" clrIdx="0">
    <p:extLst>
      <p:ext uri="{19B8F6BF-5375-455C-9EA6-DF929625EA0E}">
        <p15:presenceInfo xmlns:p15="http://schemas.microsoft.com/office/powerpoint/2012/main" userId="S-1-5-21-2163169986-1212143143-3352306574-8970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266"/>
    <p:restoredTop sz="93197"/>
  </p:normalViewPr>
  <p:slideViewPr>
    <p:cSldViewPr snapToGrid="0" snapToObjects="1">
      <p:cViewPr varScale="1">
        <p:scale>
          <a:sx n="119" d="100"/>
          <a:sy n="119" d="100"/>
        </p:scale>
        <p:origin x="1512" y="184"/>
      </p:cViewPr>
      <p:guideLst>
        <p:guide orient="horz" pos="1162"/>
        <p:guide pos="16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999011-8B2F-C049-9E14-0038DA984A4A}" type="datetimeFigureOut">
              <a:rPr lang="en-US" smtClean="0"/>
              <a:t>7/1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281D88-B074-2143-B447-9D3C00E2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45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9F284-1286-7446-88F0-4B4ADFDB1C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2CECD4-40E8-5546-91A3-33E7346ED6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F3FCAE-E534-5441-B424-7722829F6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5ACD0D-E540-9844-910A-92DE1844A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062057-B6D2-4741-8373-8F4A241AC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023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B7E14-FA29-2849-8E6F-FEB4889E57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6AC276-94BB-6147-A880-2AFAA50F0A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BC0F5C-7504-6041-A914-FE8193E65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B443F5-FFED-194D-B7CD-251C740A4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366669-507E-3A46-B380-53169F2DD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717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DD1699-005D-1144-918F-7A23E4FF0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6C68A0-40DE-884F-B5FA-FFC7AD876D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4674A-5C13-EB49-A471-5D509ADD3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E3C96-A9D7-9844-A839-A013D2EBC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8E492E-00FC-0E43-9AB0-E9BF2FCA5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266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91CE6-931C-E843-ADD3-A4790C286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C1C4A2-C22F-3349-BF1C-575B597661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3BF5A5-CF50-F54E-91FD-EFDDE6994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23C0F6-7702-8B4F-A582-77BC084DE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880404-E715-DF41-8E4B-914BC8039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610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8ABE7-6AA3-6D44-8440-44758EEB5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C1A016-854D-4C4D-A560-3738270779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4B9B0D-8858-F64D-B443-1FFE3DEB0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E37B4-C1E0-E449-B1CA-586ABF9FD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CDA329-600A-F14C-8779-6BFEA12F3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172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9535A-CAC2-404C-8718-94DBC5131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7076D9-D636-C24C-8BB3-909022B0DD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EFC9D4-2DB2-624A-A1E8-A60C724D4B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FB81A-470F-294C-9253-1E2B00CA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187996-9876-4B40-9BC7-5D3F0BA44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8A4297-EB6A-1E42-824A-C8D0920B4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64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286E9-BC81-344E-9D9B-83C88ED578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F867AF-B466-0040-ACB0-4E488181A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9F1D0B-C13E-8044-989A-6CD71622D1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62D1F4-7068-C44D-968C-7B7F8C6725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394C24-2BD8-BD48-A723-AC05F8C428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9E3ABF-0AAF-A145-8EF7-F5E405AD5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B08E8D-22CE-944D-B906-9F57CAA02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FC5D27-119E-9A40-84ED-98A3B9064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598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99B18D-60EC-7444-B720-0A374E231B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C6ED50-4E26-134D-B494-5736977B9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B2B3B2-0673-B04C-BDA1-C5E473DFD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58BB5F-E0D1-5D45-B690-D4F6CF261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08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DF7FF6-1539-304E-878B-C240732E7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72F455-2ACE-6F47-91F3-2072765A3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F7F867-646E-E54F-BF04-72DAC0042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3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3A96ED-4E47-AD48-9E55-AC952C29B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F7EC9D-0DBB-1648-8450-9FB750F9C7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81C204-591F-A141-879B-81D951F65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0FD9AC-3440-A04C-8BDF-910F870C9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C08F86-F8AC-CE49-B9C9-A529BD89A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A23681-CFB6-3046-8B82-B454C4581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2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06AC65-9849-8D41-A557-2CD6A18E7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444D1B-DD33-4D41-BEF5-9C91689816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DD6A53-FA06-DD46-ADA8-CE0C0C6301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0DE4B7-2F59-0748-94CC-4FBECD4AA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AF9C87-B4D6-3B49-A168-7B6BEA0D9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8694FC-A0C5-5A4F-9237-249A287CB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83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F1BD65-AB3B-5F4F-8E68-E89C4D5B6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B6994F-1300-5348-AE73-792A9656D4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CEC7C9-C38A-A04E-B17D-2451CB9058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3B6C2-C46D-AB46-A6DC-2AE16D93B0C4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8D64E3-B45B-4A46-9B29-A8AC9D0DB7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BA157B-A5C2-B54B-889D-1C06336F01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FE72E-2A5E-1248-9C62-0DBC4AE4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21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92001C9-4B70-D2AA-387B-4F6C40B9FD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6647" y="1184364"/>
            <a:ext cx="2159000" cy="2844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712565-FADC-AD14-E0C3-2EBC3352507C}"/>
              </a:ext>
            </a:extLst>
          </p:cNvPr>
          <p:cNvSpPr txBox="1"/>
          <p:nvPr/>
        </p:nvSpPr>
        <p:spPr>
          <a:xfrm>
            <a:off x="1805512" y="4259996"/>
            <a:ext cx="36343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" pitchFamily="2" charset="0"/>
              </a:rPr>
              <a:t>Supplemental Fig 1. </a:t>
            </a:r>
            <a:r>
              <a:rPr lang="en-US" dirty="0" err="1">
                <a:latin typeface="Times" pitchFamily="2" charset="0"/>
              </a:rPr>
              <a:t>Oró-Nolla</a:t>
            </a:r>
            <a:r>
              <a:rPr lang="en-US" dirty="0">
                <a:latin typeface="Times" pitchFamily="2" charset="0"/>
              </a:rPr>
              <a:t> </a:t>
            </a:r>
            <a:r>
              <a:rPr lang="en-US" i="1" dirty="0">
                <a:latin typeface="Times" pitchFamily="2" charset="0"/>
              </a:rPr>
              <a:t>et al</a:t>
            </a:r>
            <a:r>
              <a:rPr lang="en-US" dirty="0">
                <a:latin typeface="Times" pitchFamily="2" charset="0"/>
              </a:rPr>
              <a:t>.,</a:t>
            </a:r>
          </a:p>
        </p:txBody>
      </p:sp>
      <p:sp>
        <p:nvSpPr>
          <p:cNvPr id="4" name="Text Box 6">
            <a:extLst>
              <a:ext uri="{FF2B5EF4-FFF2-40B4-BE49-F238E27FC236}">
                <a16:creationId xmlns:a16="http://schemas.microsoft.com/office/drawing/2014/main" id="{8090A960-350F-E21B-7FB3-ECEB08A55E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00" y="996045"/>
            <a:ext cx="3390557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Times New Roman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r>
              <a:rPr lang="en-IE" sz="1100" b="1" dirty="0">
                <a:latin typeface="Times" pitchFamily="2" charset="0"/>
                <a:cs typeface="Calibri" pitchFamily="34" charset="0"/>
              </a:rPr>
              <a:t>Table 2. Demographics for immune cell analysis</a:t>
            </a:r>
            <a:endParaRPr lang="en-GB" sz="1100" b="1" dirty="0">
              <a:latin typeface="Times" pitchFamily="2" charset="0"/>
              <a:cs typeface="Calibri" pitchFamily="34" charset="0"/>
            </a:endParaRPr>
          </a:p>
        </p:txBody>
      </p:sp>
      <p:sp>
        <p:nvSpPr>
          <p:cNvPr id="5" name="Text Box 8">
            <a:extLst>
              <a:ext uri="{FF2B5EF4-FFF2-40B4-BE49-F238E27FC236}">
                <a16:creationId xmlns:a16="http://schemas.microsoft.com/office/drawing/2014/main" id="{E6B1E1D9-EBE9-5E3B-ABA4-3A3F28182E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90035" y="1227619"/>
            <a:ext cx="1319592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sz="1000">
                <a:solidFill>
                  <a:schemeClr val="tx1"/>
                </a:solidFill>
                <a:latin typeface="Times New Roman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Times New Roman" charset="0"/>
                <a:ea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r>
              <a:rPr lang="en-IE" sz="1100" b="1" dirty="0">
                <a:latin typeface="Times" pitchFamily="2" charset="0"/>
                <a:cs typeface="Calibri" pitchFamily="34" charset="0"/>
              </a:rPr>
              <a:t>HC</a:t>
            </a:r>
            <a:r>
              <a:rPr lang="en-IE" sz="1100" dirty="0">
                <a:latin typeface="Times" pitchFamily="2" charset="0"/>
                <a:cs typeface="Calibri" pitchFamily="34" charset="0"/>
              </a:rPr>
              <a:t>               	</a:t>
            </a:r>
            <a:r>
              <a:rPr lang="en-IE" sz="1100" b="1" dirty="0">
                <a:latin typeface="Times" pitchFamily="2" charset="0"/>
                <a:cs typeface="Calibri" pitchFamily="34" charset="0"/>
              </a:rPr>
              <a:t>MS</a:t>
            </a:r>
          </a:p>
          <a:p>
            <a:pPr eaLnBrk="1" hangingPunct="1">
              <a:defRPr/>
            </a:pPr>
            <a:r>
              <a:rPr lang="en-IE" sz="1100" dirty="0">
                <a:latin typeface="Calibri" pitchFamily="34" charset="0"/>
                <a:cs typeface="Calibri" pitchFamily="34" charset="0"/>
              </a:rPr>
              <a:t>                          </a:t>
            </a:r>
            <a:endParaRPr lang="en-GB" sz="11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6" name="Text Box 9">
            <a:extLst>
              <a:ext uri="{FF2B5EF4-FFF2-40B4-BE49-F238E27FC236}">
                <a16:creationId xmlns:a16="http://schemas.microsoft.com/office/drawing/2014/main" id="{7AA988FC-6E74-FD50-61B9-9F84F3B7CA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4656" y="1467550"/>
            <a:ext cx="5511218" cy="21236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GB" sz="1100" b="1" dirty="0">
                <a:latin typeface="Times" pitchFamily="2" charset="0"/>
                <a:cs typeface="Calibri" pitchFamily="34" charset="0"/>
              </a:rPr>
              <a:t>Characteristics</a:t>
            </a:r>
            <a:endParaRPr lang="en-IE" sz="1100" dirty="0">
              <a:latin typeface="Times" pitchFamily="2" charset="0"/>
              <a:cs typeface="Calibri" panose="020F0502020204030204" pitchFamily="34" charset="0"/>
            </a:endParaRP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Subjects, 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			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8	11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Age, years (mean ± SEM)		25.6 ± 2.8	45.4  ± 4.6	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Gender (F:M)			5:3	8:3	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Disease duration, years (mean ± SEM) 	n/a	9.4 ± 1.4</a:t>
            </a:r>
          </a:p>
          <a:p>
            <a:endParaRPr lang="en-IE" sz="1100" dirty="0">
              <a:latin typeface="Times" pitchFamily="2" charset="0"/>
              <a:cs typeface="Calibri" panose="020F0502020204030204" pitchFamily="34" charset="0"/>
            </a:endParaRPr>
          </a:p>
          <a:p>
            <a:r>
              <a:rPr lang="en-IE" sz="1100" b="1" i="1" dirty="0">
                <a:latin typeface="Times" pitchFamily="2" charset="0"/>
                <a:cs typeface="Calibri" panose="020F0502020204030204" pitchFamily="34" charset="0"/>
              </a:rPr>
              <a:t>MS DMTs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Fingolimod (</a:t>
            </a:r>
            <a:r>
              <a:rPr lang="en-IE" sz="1100" dirty="0" err="1">
                <a:latin typeface="Times" pitchFamily="2" charset="0"/>
                <a:cs typeface="Calibri" panose="020F0502020204030204" pitchFamily="34" charset="0"/>
              </a:rPr>
              <a:t>Gilenya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®) (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)		-	3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Natalizumab (Tysabri®) (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) 		-	1</a:t>
            </a:r>
          </a:p>
          <a:p>
            <a:r>
              <a:rPr lang="en-IE" sz="1100" dirty="0" err="1">
                <a:latin typeface="Times" pitchFamily="2" charset="0"/>
                <a:cs typeface="Calibri" panose="020F0502020204030204" pitchFamily="34" charset="0"/>
              </a:rPr>
              <a:t>Cladridine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 (</a:t>
            </a:r>
            <a:r>
              <a:rPr lang="en-IE" sz="1100" dirty="0" err="1">
                <a:latin typeface="Times" pitchFamily="2" charset="0"/>
                <a:cs typeface="Calibri" panose="020F0502020204030204" pitchFamily="34" charset="0"/>
              </a:rPr>
              <a:t>Mavenclad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®) (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) 		-	1</a:t>
            </a:r>
          </a:p>
          <a:p>
            <a:r>
              <a:rPr lang="en-IE" sz="1100" dirty="0" err="1">
                <a:latin typeface="Times" pitchFamily="2" charset="0"/>
                <a:cs typeface="Calibri" panose="020F0502020204030204" pitchFamily="34" charset="0"/>
              </a:rPr>
              <a:t>Dimethylfumarate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  (Tecfidera®)	 (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) 	-	1</a:t>
            </a:r>
          </a:p>
          <a:p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No DMT (</a:t>
            </a:r>
            <a:r>
              <a:rPr lang="en-IE" sz="1100" i="1" dirty="0">
                <a:latin typeface="Times" pitchFamily="2" charset="0"/>
                <a:cs typeface="Calibri" panose="020F0502020204030204" pitchFamily="34" charset="0"/>
              </a:rPr>
              <a:t>n</a:t>
            </a:r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) 			-	5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094ABFE-6ED8-5775-25A3-3D2E51A7C8E2}"/>
              </a:ext>
            </a:extLst>
          </p:cNvPr>
          <p:cNvCxnSpPr>
            <a:cxnSpLocks/>
          </p:cNvCxnSpPr>
          <p:nvPr/>
        </p:nvCxnSpPr>
        <p:spPr>
          <a:xfrm>
            <a:off x="6167439" y="3595425"/>
            <a:ext cx="43860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6BB557D0-462C-FF54-25DF-28E10151E797}"/>
              </a:ext>
            </a:extLst>
          </p:cNvPr>
          <p:cNvCxnSpPr>
            <a:cxnSpLocks/>
          </p:cNvCxnSpPr>
          <p:nvPr/>
        </p:nvCxnSpPr>
        <p:spPr>
          <a:xfrm>
            <a:off x="6167439" y="1468790"/>
            <a:ext cx="43860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7FAA862-6774-44B2-1924-64F39FBBF59B}"/>
              </a:ext>
            </a:extLst>
          </p:cNvPr>
          <p:cNvCxnSpPr>
            <a:cxnSpLocks/>
          </p:cNvCxnSpPr>
          <p:nvPr/>
        </p:nvCxnSpPr>
        <p:spPr>
          <a:xfrm>
            <a:off x="6167439" y="1257655"/>
            <a:ext cx="43860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 Box 9">
            <a:extLst>
              <a:ext uri="{FF2B5EF4-FFF2-40B4-BE49-F238E27FC236}">
                <a16:creationId xmlns:a16="http://schemas.microsoft.com/office/drawing/2014/main" id="{9F29DAB9-A99E-65B2-0FDE-C20FE62B78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4419" y="3574196"/>
            <a:ext cx="4386075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just"/>
            <a:r>
              <a:rPr lang="en-IE" sz="1100" dirty="0">
                <a:latin typeface="Times" pitchFamily="2" charset="0"/>
                <a:cs typeface="Calibri" panose="020F0502020204030204" pitchFamily="34" charset="0"/>
              </a:rPr>
              <a:t>Data are expressed as mean ± SEM; HC: Healthy control cases; MS: multiple sclerosis; n/a: not applicable. </a:t>
            </a:r>
            <a:endParaRPr lang="en-IE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IE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7328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08BDB75-2488-56A2-4FF4-B316C07E4184}"/>
              </a:ext>
            </a:extLst>
          </p:cNvPr>
          <p:cNvSpPr txBox="1"/>
          <p:nvPr/>
        </p:nvSpPr>
        <p:spPr>
          <a:xfrm>
            <a:off x="6280658" y="4610670"/>
            <a:ext cx="36343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" pitchFamily="2" charset="0"/>
              </a:rPr>
              <a:t>Supplemental Fig 2. </a:t>
            </a:r>
            <a:r>
              <a:rPr lang="en-US" dirty="0" err="1">
                <a:latin typeface="Times" pitchFamily="2" charset="0"/>
              </a:rPr>
              <a:t>Oró-Nolla</a:t>
            </a:r>
            <a:r>
              <a:rPr lang="en-US" dirty="0">
                <a:latin typeface="Times" pitchFamily="2" charset="0"/>
              </a:rPr>
              <a:t> </a:t>
            </a:r>
            <a:r>
              <a:rPr lang="en-US" i="1" dirty="0">
                <a:latin typeface="Times" pitchFamily="2" charset="0"/>
              </a:rPr>
              <a:t>et al</a:t>
            </a:r>
            <a:r>
              <a:rPr lang="en-US" dirty="0">
                <a:latin typeface="Times" pitchFamily="2" charset="0"/>
              </a:rPr>
              <a:t>.,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CEC4C0B-C165-87ED-17C4-B14E1E6DF4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9452" y="1712403"/>
            <a:ext cx="2159000" cy="279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5337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5</TotalTime>
  <Words>174</Words>
  <Application>Microsoft Macintosh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Times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Downer</dc:creator>
  <cp:lastModifiedBy>Eric Downer</cp:lastModifiedBy>
  <cp:revision>83</cp:revision>
  <cp:lastPrinted>2025-06-10T09:03:55Z</cp:lastPrinted>
  <dcterms:created xsi:type="dcterms:W3CDTF">2024-10-03T12:57:08Z</dcterms:created>
  <dcterms:modified xsi:type="dcterms:W3CDTF">2025-07-18T16:33:31Z</dcterms:modified>
</cp:coreProperties>
</file>